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3657600" cy="3657600"/>
  <p:notesSz cx="6858000" cy="9144000"/>
  <p:defaultTextStyle>
    <a:defPPr>
      <a:defRPr lang="en-US"/>
    </a:defPPr>
    <a:lvl1pPr marL="0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1pPr>
    <a:lvl2pPr marL="208986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2pPr>
    <a:lvl3pPr marL="417972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3pPr>
    <a:lvl4pPr marL="626958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4pPr>
    <a:lvl5pPr marL="835944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5pPr>
    <a:lvl6pPr marL="1044931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6pPr>
    <a:lvl7pPr marL="1253917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7pPr>
    <a:lvl8pPr marL="1462903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8pPr>
    <a:lvl9pPr marL="1671889" algn="l" defTabSz="417972" rtl="0" eaLnBrk="1" latinLnBrk="0" hangingPunct="1">
      <a:defRPr sz="82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200" d="100"/>
          <a:sy n="200" d="100"/>
        </p:scale>
        <p:origin x="89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" y="598593"/>
            <a:ext cx="3108960" cy="1273387"/>
          </a:xfrm>
        </p:spPr>
        <p:txBody>
          <a:bodyPr anchor="b"/>
          <a:lstStyle>
            <a:lvl1pPr algn="ctr"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" y="1921087"/>
            <a:ext cx="2743200" cy="883073"/>
          </a:xfrm>
        </p:spPr>
        <p:txBody>
          <a:bodyPr/>
          <a:lstStyle>
            <a:lvl1pPr marL="0" indent="0" algn="ctr">
              <a:buNone/>
              <a:defRPr sz="960"/>
            </a:lvl1pPr>
            <a:lvl2pPr marL="182880" indent="0" algn="ctr">
              <a:buNone/>
              <a:defRPr sz="800"/>
            </a:lvl2pPr>
            <a:lvl3pPr marL="365760" indent="0" algn="ctr">
              <a:buNone/>
              <a:defRPr sz="720"/>
            </a:lvl3pPr>
            <a:lvl4pPr marL="548640" indent="0" algn="ctr">
              <a:buNone/>
              <a:defRPr sz="640"/>
            </a:lvl4pPr>
            <a:lvl5pPr marL="731520" indent="0" algn="ctr">
              <a:buNone/>
              <a:defRPr sz="640"/>
            </a:lvl5pPr>
            <a:lvl6pPr marL="914400" indent="0" algn="ctr">
              <a:buNone/>
              <a:defRPr sz="640"/>
            </a:lvl6pPr>
            <a:lvl7pPr marL="1097280" indent="0" algn="ctr">
              <a:buNone/>
              <a:defRPr sz="640"/>
            </a:lvl7pPr>
            <a:lvl8pPr marL="1280160" indent="0" algn="ctr">
              <a:buNone/>
              <a:defRPr sz="640"/>
            </a:lvl8pPr>
            <a:lvl9pPr marL="1463040" indent="0" algn="ctr">
              <a:buNone/>
              <a:defRPr sz="6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05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187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" y="194733"/>
            <a:ext cx="788670" cy="30996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" y="194733"/>
            <a:ext cx="2320290" cy="309964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457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02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" y="911861"/>
            <a:ext cx="3154680" cy="15214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" y="2447714"/>
            <a:ext cx="3154680" cy="800100"/>
          </a:xfrm>
        </p:spPr>
        <p:txBody>
          <a:bodyPr/>
          <a:lstStyle>
            <a:lvl1pPr marL="0" indent="0">
              <a:buNone/>
              <a:defRPr sz="960">
                <a:solidFill>
                  <a:schemeClr val="tx1"/>
                </a:solidFill>
              </a:defRPr>
            </a:lvl1pPr>
            <a:lvl2pPr marL="18288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2pPr>
            <a:lvl3pPr marL="365760" indent="0">
              <a:buNone/>
              <a:defRPr sz="720">
                <a:solidFill>
                  <a:schemeClr val="tx1">
                    <a:tint val="75000"/>
                  </a:schemeClr>
                </a:solidFill>
              </a:defRPr>
            </a:lvl3pPr>
            <a:lvl4pPr marL="5486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4pPr>
            <a:lvl5pPr marL="73152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5pPr>
            <a:lvl6pPr marL="91440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6pPr>
            <a:lvl7pPr marL="109728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7pPr>
            <a:lvl8pPr marL="128016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8pPr>
            <a:lvl9pPr marL="14630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356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" y="973666"/>
            <a:ext cx="1554480" cy="232071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" y="973666"/>
            <a:ext cx="1554480" cy="232071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791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" y="194734"/>
            <a:ext cx="3154680" cy="70696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7" y="896620"/>
            <a:ext cx="1547336" cy="439420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7" y="1336040"/>
            <a:ext cx="1547336" cy="196511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" y="896620"/>
            <a:ext cx="1554956" cy="439420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" y="1336040"/>
            <a:ext cx="1554956" cy="196511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370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0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112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7" y="243840"/>
            <a:ext cx="1179671" cy="85344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" y="526627"/>
            <a:ext cx="1851660" cy="2599267"/>
          </a:xfrm>
        </p:spPr>
        <p:txBody>
          <a:bodyPr/>
          <a:lstStyle>
            <a:lvl1pPr>
              <a:defRPr sz="1280"/>
            </a:lvl1pPr>
            <a:lvl2pPr>
              <a:defRPr sz="1120"/>
            </a:lvl2pPr>
            <a:lvl3pPr>
              <a:defRPr sz="96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7" y="1097280"/>
            <a:ext cx="1179671" cy="2032847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289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7" y="243840"/>
            <a:ext cx="1179671" cy="85344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" y="526627"/>
            <a:ext cx="1851660" cy="2599267"/>
          </a:xfrm>
        </p:spPr>
        <p:txBody>
          <a:bodyPr anchor="t"/>
          <a:lstStyle>
            <a:lvl1pPr marL="0" indent="0">
              <a:buNone/>
              <a:defRPr sz="1280"/>
            </a:lvl1pPr>
            <a:lvl2pPr marL="182880" indent="0">
              <a:buNone/>
              <a:defRPr sz="1120"/>
            </a:lvl2pPr>
            <a:lvl3pPr marL="365760" indent="0">
              <a:buNone/>
              <a:defRPr sz="960"/>
            </a:lvl3pPr>
            <a:lvl4pPr marL="548640" indent="0">
              <a:buNone/>
              <a:defRPr sz="800"/>
            </a:lvl4pPr>
            <a:lvl5pPr marL="731520" indent="0">
              <a:buNone/>
              <a:defRPr sz="800"/>
            </a:lvl5pPr>
            <a:lvl6pPr marL="914400" indent="0">
              <a:buNone/>
              <a:defRPr sz="800"/>
            </a:lvl6pPr>
            <a:lvl7pPr marL="1097280" indent="0">
              <a:buNone/>
              <a:defRPr sz="800"/>
            </a:lvl7pPr>
            <a:lvl8pPr marL="1280160" indent="0">
              <a:buNone/>
              <a:defRPr sz="800"/>
            </a:lvl8pPr>
            <a:lvl9pPr marL="1463040" indent="0">
              <a:buNone/>
              <a:defRPr sz="8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7" y="1097280"/>
            <a:ext cx="1179671" cy="2032847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3045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" y="194734"/>
            <a:ext cx="3154680" cy="7069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" y="973666"/>
            <a:ext cx="3154680" cy="2320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" y="3390054"/>
            <a:ext cx="82296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7239B-39DC-4EFB-904E-6FFD1F2AF737}" type="datetimeFigureOut">
              <a:rPr lang="en-US" smtClean="0"/>
              <a:t>10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" y="3390054"/>
            <a:ext cx="123444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" y="3390054"/>
            <a:ext cx="82296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01935-F444-4806-BE86-CEF08B868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449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65760" rtl="0" eaLnBrk="1" latinLnBrk="0" hangingPunct="1">
        <a:lnSpc>
          <a:spcPct val="90000"/>
        </a:lnSpc>
        <a:spcBef>
          <a:spcPct val="0"/>
        </a:spcBef>
        <a:buNone/>
        <a:defRPr sz="17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36576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12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194" y="83137"/>
            <a:ext cx="3529406" cy="2644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0" y="2788497"/>
            <a:ext cx="3657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Fig.</a:t>
            </a:r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aplan-Meyer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curves of lung neuroendocrine tumors for overall survival according to the different patterns of p16</a:t>
            </a:r>
            <a:r>
              <a:rPr lang="en-US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nk4A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expression.</a:t>
            </a:r>
          </a:p>
        </p:txBody>
      </p:sp>
    </p:spTree>
    <p:extLst>
      <p:ext uri="{BB962C8B-B14F-4D97-AF65-F5344CB8AC3E}">
        <p14:creationId xmlns:p14="http://schemas.microsoft.com/office/powerpoint/2010/main" val="753494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2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 Fusco</dc:creator>
  <cp:lastModifiedBy>Nicola Fusco</cp:lastModifiedBy>
  <cp:revision>7</cp:revision>
  <dcterms:created xsi:type="dcterms:W3CDTF">2015-03-31T21:01:03Z</dcterms:created>
  <dcterms:modified xsi:type="dcterms:W3CDTF">2015-10-19T12:35:31Z</dcterms:modified>
</cp:coreProperties>
</file>